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36B214-76FB-43F0-A79B-4C5F61382C0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C5695F-D924-48C6-A297-BC990F234D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047B73-7418-4BDB-8D65-3C7AA1F485C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445A21-BB85-48FD-88FC-54B95415EE0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0F4C84-8CCD-4CE4-A52D-00281511AF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FFF1A4-8405-4D41-9CD1-2034C5CFCC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16181C-A591-4742-9907-E4E01D96B1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4A763B-E6DE-4FCC-9267-E4F21A2DDE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A5CC2E-FEEB-48A8-87F3-2019A79B55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E5AD5C-F408-4F71-B60D-3BD411BEC4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3BA3B5-F29A-43EB-AC7C-A6FDCBBDF1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A733DE-8265-4026-8251-863FE6C1E1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9BC78F-71DC-4096-8185-7839C86AAF9F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89000" y="1116000"/>
          <a:ext cx="6480000" cy="7472520"/>
        </p:xfrm>
        <a:graphic>
          <a:graphicData uri="http://schemas.openxmlformats.org/drawingml/2006/table">
            <a:tbl>
              <a:tblPr/>
              <a:tblGrid>
                <a:gridCol w="1546200"/>
                <a:gridCol w="368280"/>
                <a:gridCol w="2209680"/>
                <a:gridCol w="368280"/>
                <a:gridCol w="736560"/>
                <a:gridCol w="819360"/>
                <a:gridCol w="431640"/>
              </a:tblGrid>
              <a:tr h="28728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4"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he criteria shown in Fig. 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50328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arget gen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equence (5'- 3'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GC content of the  12bp flanking regions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,H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116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pstream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ownstream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504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m_</a:t>
                      </a: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b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GenBank ID: AB505052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CUAAAGCAGAUUGUUCAA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UGAACAAUCUGCUUUAGGA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6648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GUUCCACACGAACCACU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UGGUUCGUGUGGAACUC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0184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m_</a:t>
                      </a: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od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China Gene model: BGIBMGA009541-TA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AAUACUGCAAUCGCCAA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UGGCGAUUGCAGUAUUUG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6684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UAUCCUCGUCCAAUGCAAT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UGCAUUGGACGAGGAUAGT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504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m_</a:t>
                      </a: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nt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GenBank ID: D14169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AGAUUGGCCAGAGAGAA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UCUCUCUGGCCAAUCUUC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6648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UGCUCCACGAGAAACUUU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AAGUUUCUCGUGGAGCAG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540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m_</a:t>
                      </a: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H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GenBank ID: AB439286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AGAAGUGAUCUUGCAAA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UUGCAAGAUCACUUCUUC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6504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UCAGCAUGACUCGUAUUA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AAUACGAGUCAUGCUGAC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0328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846 (function unknown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China Gene model: BGIBMGA008846-TA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CUAUUAAAACCUGAAAUA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AUUUCAGGUUUUAAUAGC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6648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CUCUAUUGUAACUUUAAA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UUAAAGUUACAAUAGAGC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0184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m_</a:t>
                      </a: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o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China Gene model: BGIBMGA009037-TA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UAACGAGCAGUGCACAAA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UUGUGCACUGCUCGUUAC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6684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GAACAUUGUUUUUGAGU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CUCAAAAACAAUGUUCUC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0292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m_</a:t>
                      </a: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pz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China Gene model: BGIBMGA009036-TA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GACCUGUUUCGACUCAU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UGAGUCGAAACAGGUCUG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6540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GAAUUCGAGGCUAGAUA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AUCUAGCCUCGAAUUCUG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6504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UGAAUACACAGUUUGAUAA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AUCAAACUGUGUAUUCAC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6684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GAACAAAGCGUUGAUAAA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UAUCAACGCUUUGUUCUCG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✓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テキスト ボックス 4"/>
          <p:cNvSpPr/>
          <p:nvPr/>
        </p:nvSpPr>
        <p:spPr>
          <a:xfrm>
            <a:off x="182520" y="766800"/>
            <a:ext cx="2851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able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1. All sequences of the siRNA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5T07:42:36Z</dcterms:created>
  <dc:creator> </dc:creator>
  <dc:description/>
  <dc:language>en-US</dc:language>
  <cp:lastModifiedBy> </cp:lastModifiedBy>
  <dcterms:modified xsi:type="dcterms:W3CDTF">2011-04-21T11:44:34Z</dcterms:modified>
  <cp:revision>3</cp:revision>
  <dc:subject/>
  <dc:title>スライド 1</dc:title>
</cp:coreProperties>
</file>